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2B9347-7EF3-4D27-8742-AC105F0D44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D2564-166F-4B6C-BD6A-796891736B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EB62C4-A3D2-407A-BA89-710BE24B493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1CD2E2-AAD4-4D32-AB09-9CF2D3DCBD1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5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8F11AF-46CC-4AC0-B51B-2EC5D44D82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4E9BA4-6F79-4781-BE35-9B55BDB977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2614F8-148B-48B3-B9C2-1CAA2B900D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522103-52B8-4DA1-A227-6AFB80B132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922B83-24FA-42CB-95CE-0E4268D1D0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8882B-826C-4AFF-AB2A-A5EC67EBB8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C65519-B86B-41FD-9721-C3594ECB12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36E33E-0187-4E54-8BD4-D0B1A23A6C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7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marL="365040" indent="-36504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1" marL="793800" indent="-30492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2" marL="1220760" indent="-24300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3" marL="1709640" indent="-24264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4" marL="2197080" indent="-24300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5" marL="2197080" indent="-24300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6" marL="2197080" indent="-24300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0000"/>
            <a:ext cx="1600200" cy="5288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3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0000"/>
            <a:ext cx="2171520" cy="5288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0000"/>
            <a:ext cx="1600200" cy="5288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259D5E-880C-4E6A-ACD9-DB784D108AE6}" type="slidenum">
              <a:rPr b="0" lang="fr-FR" sz="1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7"/>
          <p:cNvSpPr/>
          <p:nvPr/>
        </p:nvSpPr>
        <p:spPr>
          <a:xfrm>
            <a:off x="44280" y="299880"/>
            <a:ext cx="6755040" cy="24019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ZoneTexte 5"/>
          <p:cNvSpPr/>
          <p:nvPr/>
        </p:nvSpPr>
        <p:spPr>
          <a:xfrm>
            <a:off x="54000" y="299880"/>
            <a:ext cx="653580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A: </a:t>
            </a:r>
            <a:r>
              <a:rPr b="1" lang="fr-FR" sz="1100" spc="-1" strike="noStrike" u="sng">
                <a:solidFill>
                  <a:srgbClr val="000000"/>
                </a:solidFill>
                <a:uFillTx/>
                <a:latin typeface="Calibri"/>
                <a:ea typeface="Arial"/>
              </a:rPr>
              <a:t>Ingenuity Pathways:</a:t>
            </a: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 Role of pattern recognition receptors in recognition of bacteria and viruses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tangle 57"/>
          <p:cNvSpPr/>
          <p:nvPr/>
        </p:nvSpPr>
        <p:spPr>
          <a:xfrm>
            <a:off x="44280" y="2757600"/>
            <a:ext cx="6755040" cy="1611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ZoneTexte 5"/>
          <p:cNvSpPr/>
          <p:nvPr/>
        </p:nvSpPr>
        <p:spPr>
          <a:xfrm>
            <a:off x="54000" y="2757600"/>
            <a:ext cx="65167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B: Same expression profils between HERVs and genes 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Picture 27" descr=""/>
          <p:cNvPicPr/>
          <p:nvPr/>
        </p:nvPicPr>
        <p:blipFill>
          <a:blip r:embed="rId1"/>
          <a:stretch/>
        </p:blipFill>
        <p:spPr>
          <a:xfrm>
            <a:off x="561960" y="542880"/>
            <a:ext cx="5697720" cy="2044800"/>
          </a:xfrm>
          <a:prstGeom prst="rect">
            <a:avLst/>
          </a:prstGeom>
          <a:ln w="0">
            <a:noFill/>
          </a:ln>
        </p:spPr>
      </p:pic>
      <p:cxnSp>
        <p:nvCxnSpPr>
          <p:cNvPr id="46" name="Connecteur droit avec flèche 4"/>
          <p:cNvCxnSpPr>
            <a:stCxn id="47" idx="0"/>
          </p:cNvCxnSpPr>
          <p:nvPr/>
        </p:nvCxnSpPr>
        <p:spPr>
          <a:xfrm flipV="1">
            <a:off x="1221480" y="701280"/>
            <a:ext cx="1823760" cy="349920"/>
          </a:xfrm>
          <a:prstGeom prst="straightConnector1">
            <a:avLst/>
          </a:prstGeom>
          <a:ln w="936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48" name="ZoneTexte 5"/>
          <p:cNvSpPr/>
          <p:nvPr/>
        </p:nvSpPr>
        <p:spPr>
          <a:xfrm>
            <a:off x="3044880" y="576360"/>
            <a:ext cx="102564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C3AR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Image 1" descr=""/>
          <p:cNvPicPr/>
          <p:nvPr/>
        </p:nvPicPr>
        <p:blipFill>
          <a:blip r:embed="rId2"/>
          <a:stretch/>
        </p:blipFill>
        <p:spPr>
          <a:xfrm>
            <a:off x="307800" y="3070080"/>
            <a:ext cx="6251760" cy="1138320"/>
          </a:xfrm>
          <a:prstGeom prst="rect">
            <a:avLst/>
          </a:prstGeom>
          <a:ln w="0">
            <a:noFill/>
          </a:ln>
        </p:spPr>
      </p:pic>
      <p:sp>
        <p:nvSpPr>
          <p:cNvPr id="47" name="Rectangle 14"/>
          <p:cNvSpPr/>
          <p:nvPr/>
        </p:nvSpPr>
        <p:spPr>
          <a:xfrm>
            <a:off x="1117440" y="1050840"/>
            <a:ext cx="208080" cy="25884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16"/>
          <p:cNvSpPr/>
          <p:nvPr/>
        </p:nvSpPr>
        <p:spPr>
          <a:xfrm>
            <a:off x="44280" y="4408560"/>
            <a:ext cx="6755040" cy="50324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1" name=""/>
          <p:cNvGraphicFramePr/>
          <p:nvPr/>
        </p:nvGraphicFramePr>
        <p:xfrm>
          <a:off x="165240" y="4695840"/>
          <a:ext cx="6505560" cy="4610160"/>
        </p:xfrm>
        <a:graphic>
          <a:graphicData uri="http://schemas.openxmlformats.org/drawingml/2006/table">
            <a:tbl>
              <a:tblPr/>
              <a:tblGrid>
                <a:gridCol w="868320"/>
                <a:gridCol w="164880"/>
                <a:gridCol w="165240"/>
                <a:gridCol w="201600"/>
                <a:gridCol w="163440"/>
                <a:gridCol w="201600"/>
                <a:gridCol w="139680"/>
                <a:gridCol w="152640"/>
                <a:gridCol w="152280"/>
                <a:gridCol w="152280"/>
                <a:gridCol w="152640"/>
                <a:gridCol w="152280"/>
                <a:gridCol w="152280"/>
                <a:gridCol w="152640"/>
                <a:gridCol w="152280"/>
                <a:gridCol w="168120"/>
                <a:gridCol w="136800"/>
                <a:gridCol w="152280"/>
                <a:gridCol w="152280"/>
                <a:gridCol w="185760"/>
                <a:gridCol w="119160"/>
                <a:gridCol w="193680"/>
                <a:gridCol w="112680"/>
                <a:gridCol w="152280"/>
                <a:gridCol w="152640"/>
                <a:gridCol w="152280"/>
                <a:gridCol w="152280"/>
                <a:gridCol w="152640"/>
                <a:gridCol w="152280"/>
                <a:gridCol w="152280"/>
                <a:gridCol w="152640"/>
                <a:gridCol w="152280"/>
                <a:gridCol w="152280"/>
                <a:gridCol w="131760"/>
                <a:gridCol w="150840"/>
                <a:gridCol w="150840"/>
                <a:gridCol w="203400"/>
              </a:tblGrid>
              <a:tr h="44244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hways/Genes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3AR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5AR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LEC7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CSF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FIH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IL1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RF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AS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AS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X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PK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LT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LTN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L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XCL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8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FCGR3A-3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23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ZBP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3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GS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LPL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MP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MOX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OCS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FN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SERPINE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X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IM2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SB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XCL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NAIP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P2R1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PI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MMP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t" anchorCtr="1" vert="eaVer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4720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ole of Pattern Recognition Receptors in Recognition of Bacteria and Viruses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4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8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4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37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42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39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39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8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82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  <a:tr h="27576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F-kB Signal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1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1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  <a:tr h="20772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Toll-like Receptor Signal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  <a:tr h="27396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flammasome pathway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8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1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9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  <a:tr h="27612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ute Phase Response Signal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3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6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9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  <a:tr h="27576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EM1 Signal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3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3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26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  <a:tr h="20772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ndritic Cell Maturation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3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</a:t>
                      </a: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1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  <a:tr h="45648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tivation of IRF by Cytosolic Pattern Recognition Receptors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30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30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  <a:tr h="36612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ole of RIG1-like Receptors in Antiviral Innate Immunity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21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21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  <a:tr h="27432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erferon Signal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36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36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  <a:tr h="45648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duction of Nitric Oxide and Reactive Oxygen Species in Macrophages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5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6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1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  <a:tr h="27612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XR/RXR Activation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4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3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6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23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  <a:tr h="273960">
                <a:tc>
                  <a:txBody>
                    <a:bodyPr lIns="2160" rIns="216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Colorectal Cancer Metastasis Signal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2160" rIns="216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a6a6a6"/>
                    </a:solidFill>
                  </a:tcPr>
                </a:tc>
              </a:tr>
            </a:tbl>
          </a:graphicData>
        </a:graphic>
      </p:graphicFrame>
      <p:sp>
        <p:nvSpPr>
          <p:cNvPr id="52" name="ZoneTexte 5"/>
          <p:cNvSpPr/>
          <p:nvPr/>
        </p:nvSpPr>
        <p:spPr>
          <a:xfrm>
            <a:off x="47520" y="4408560"/>
            <a:ext cx="672804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C: Descriptive table of HERVs associated with immunity genes 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Rectangle 4"/>
          <p:cNvSpPr/>
          <p:nvPr/>
        </p:nvSpPr>
        <p:spPr>
          <a:xfrm>
            <a:off x="357120" y="343080"/>
            <a:ext cx="6121440" cy="91454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Image 1" descr=""/>
          <p:cNvPicPr/>
          <p:nvPr/>
        </p:nvPicPr>
        <p:blipFill>
          <a:blip r:embed="rId1"/>
          <a:srcRect l="7504" t="5268" r="6694" b="4976"/>
          <a:stretch/>
        </p:blipFill>
        <p:spPr>
          <a:xfrm>
            <a:off x="968400" y="631800"/>
            <a:ext cx="4922640" cy="8640720"/>
          </a:xfrm>
          <a:prstGeom prst="rect">
            <a:avLst/>
          </a:prstGeom>
          <a:ln w="0">
            <a:noFill/>
          </a:ln>
        </p:spPr>
      </p:pic>
      <p:sp>
        <p:nvSpPr>
          <p:cNvPr id="55" name="ZoneTexte 5"/>
          <p:cNvSpPr/>
          <p:nvPr/>
        </p:nvSpPr>
        <p:spPr>
          <a:xfrm>
            <a:off x="366840" y="344520"/>
            <a:ext cx="653544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D: Global landscap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Rectangle 5"/>
          <p:cNvSpPr/>
          <p:nvPr/>
        </p:nvSpPr>
        <p:spPr>
          <a:xfrm>
            <a:off x="92160" y="200160"/>
            <a:ext cx="6649920" cy="44640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Picture 2" descr=""/>
          <p:cNvPicPr/>
          <p:nvPr/>
        </p:nvPicPr>
        <p:blipFill>
          <a:blip r:embed="rId1"/>
          <a:stretch/>
        </p:blipFill>
        <p:spPr>
          <a:xfrm>
            <a:off x="536400" y="712800"/>
            <a:ext cx="5761080" cy="3878280"/>
          </a:xfrm>
          <a:prstGeom prst="rect">
            <a:avLst/>
          </a:prstGeom>
          <a:ln w="0">
            <a:noFill/>
          </a:ln>
        </p:spPr>
      </p:pic>
      <p:sp>
        <p:nvSpPr>
          <p:cNvPr id="58" name="ZoneTexte 5"/>
          <p:cNvSpPr/>
          <p:nvPr/>
        </p:nvSpPr>
        <p:spPr>
          <a:xfrm>
            <a:off x="92160" y="200160"/>
            <a:ext cx="6649920" cy="43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E: </a:t>
            </a:r>
            <a:r>
              <a:rPr b="1" lang="en-GB" sz="1100" spc="-1" strike="noStrike">
                <a:solidFill>
                  <a:srgbClr val="000000"/>
                </a:solidFill>
                <a:latin typeface="Calibri"/>
                <a:ea typeface="Arial"/>
              </a:rPr>
              <a:t>PTGS2 and FLT1 associated HERVs/MaLRs  at the crossroads of “LXR/RXR activation” and “NF-kB signalling” pathway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9-17T08:32:57Z</dcterms:created>
  <dc:creator>MOMMERT Marine</dc:creator>
  <dc:description/>
  <dc:language>en-US</dc:language>
  <cp:lastModifiedBy>MOMMERT Marine</cp:lastModifiedBy>
  <dcterms:modified xsi:type="dcterms:W3CDTF">2018-05-13T19:10:45Z</dcterms:modified>
  <cp:revision>23</cp:revision>
  <dc:subject/>
  <dc:title>Présentation PowerPoint</dc:title>
</cp:coreProperties>
</file>